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82804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F5FD05-F1A5-470F-BBD7-7C671CAF95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31920"/>
            <a:ext cx="6172200" cy="13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1932120"/>
            <a:ext cx="617220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4786200"/>
            <a:ext cx="617220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367E6-54FF-4023-B3B5-57A9A9DD03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31920"/>
            <a:ext cx="6172200" cy="13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1932120"/>
            <a:ext cx="301176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1932120"/>
            <a:ext cx="301176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4786200"/>
            <a:ext cx="301176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4786200"/>
            <a:ext cx="301176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F648F7-8A07-475B-9A76-9813AF9621B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31920"/>
            <a:ext cx="6172200" cy="13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1932120"/>
            <a:ext cx="198720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1932120"/>
            <a:ext cx="198720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1932120"/>
            <a:ext cx="198720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4786200"/>
            <a:ext cx="198720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4786200"/>
            <a:ext cx="198720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4786200"/>
            <a:ext cx="198720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1551D0-E5ED-4CE5-9AA0-4503C69CBA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31920"/>
            <a:ext cx="6172200" cy="13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1932120"/>
            <a:ext cx="6172200" cy="5464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A94BFB-D2D1-4FEF-9D83-3E51F85936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31920"/>
            <a:ext cx="6172200" cy="13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1932120"/>
            <a:ext cx="6172200" cy="546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26F7C-40D3-49DC-9180-02E21E263D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31920"/>
            <a:ext cx="6172200" cy="13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1932120"/>
            <a:ext cx="3011760" cy="546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1932120"/>
            <a:ext cx="3011760" cy="546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3DECA4-B2FB-4A49-86E3-E8D4B88F9C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31920"/>
            <a:ext cx="6172200" cy="13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B336F-93C1-46D8-9FA4-E69563535D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31920"/>
            <a:ext cx="6172200" cy="639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6278B-BC26-406F-B9CF-2E7538D301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31920"/>
            <a:ext cx="6172200" cy="13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1932120"/>
            <a:ext cx="301176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1932120"/>
            <a:ext cx="3011760" cy="546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4786200"/>
            <a:ext cx="301176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237290-7874-4408-88A8-EFB1969091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31920"/>
            <a:ext cx="6172200" cy="13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1932120"/>
            <a:ext cx="3011760" cy="546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1932120"/>
            <a:ext cx="301176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4786200"/>
            <a:ext cx="301176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C661C0-340B-416F-A65F-6EE9A409C2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31920"/>
            <a:ext cx="6172200" cy="13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1932120"/>
            <a:ext cx="301176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1932120"/>
            <a:ext cx="301176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4786200"/>
            <a:ext cx="6172200" cy="260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13D43-4D46-46B9-9FF0-8D063173D7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31920"/>
            <a:ext cx="6172200" cy="13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1932120"/>
            <a:ext cx="6172200" cy="546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7538760"/>
            <a:ext cx="1600200" cy="57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7538760"/>
            <a:ext cx="2171520" cy="57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7538760"/>
            <a:ext cx="1600200" cy="57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7E81F8-25AA-409D-AE52-617252B7DC8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4400" y="289080"/>
            <a:ext cx="6831000" cy="7704720"/>
            <a:chOff x="14400" y="289080"/>
            <a:chExt cx="6831000" cy="7704720"/>
          </a:xfrm>
        </p:grpSpPr>
        <p:grpSp>
          <p:nvGrpSpPr>
            <p:cNvPr id="42" name=""/>
            <p:cNvGrpSpPr/>
            <p:nvPr/>
          </p:nvGrpSpPr>
          <p:grpSpPr>
            <a:xfrm>
              <a:off x="14400" y="936720"/>
              <a:ext cx="6831000" cy="2879640"/>
              <a:chOff x="14400" y="936720"/>
              <a:chExt cx="6831000" cy="2879640"/>
            </a:xfrm>
          </p:grpSpPr>
          <p:pic>
            <p:nvPicPr>
              <p:cNvPr id="43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14400" y="936720"/>
                <a:ext cx="6831000" cy="2879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"/>
              <p:cNvSpPr/>
              <p:nvPr/>
            </p:nvSpPr>
            <p:spPr>
              <a:xfrm>
                <a:off x="5783400" y="1027080"/>
                <a:ext cx="1008000" cy="538200"/>
              </a:xfrm>
              <a:prstGeom prst="rect">
                <a:avLst/>
              </a:prstGeom>
              <a:solidFill>
                <a:srgbClr val="fff7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5" name=""/>
            <p:cNvSpPr/>
            <p:nvPr/>
          </p:nvSpPr>
          <p:spPr>
            <a:xfrm>
              <a:off x="176400" y="5180040"/>
              <a:ext cx="6478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633840" y="4773600"/>
              <a:ext cx="904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000000"/>
                  </a:solidFill>
                  <a:latin typeface="Arial"/>
                </a:rPr>
                <a:t>Tissu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211920" y="57690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3.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211920" y="61182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3.7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846160" y="7169400"/>
              <a:ext cx="1306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23.8 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± 0.02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211920" y="64692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3.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211920" y="68184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3.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516920" y="57690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5.9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516920" y="61182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5.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208400" y="7169400"/>
              <a:ext cx="1194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25.5 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± 0.1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516920" y="64692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5.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516920" y="68184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5.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767920" y="57690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4.7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767920" y="61182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4.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767920" y="64692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4.9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767920" y="68184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4.7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459040" y="7169400"/>
              <a:ext cx="1194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24.8 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± 0.0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906920" y="57690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4.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906920" y="61182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4.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596960" y="7169400"/>
              <a:ext cx="1194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24.1 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± 0.0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906920" y="64692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4.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906920" y="68184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4.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7" name=""/>
            <p:cNvGrpSpPr/>
            <p:nvPr/>
          </p:nvGrpSpPr>
          <p:grpSpPr>
            <a:xfrm>
              <a:off x="1834560" y="5249880"/>
              <a:ext cx="4622040" cy="368280"/>
              <a:chOff x="1834560" y="5249880"/>
              <a:chExt cx="4622040" cy="368280"/>
            </a:xfrm>
          </p:grpSpPr>
          <p:sp>
            <p:nvSpPr>
              <p:cNvPr id="68" name=""/>
              <p:cNvSpPr/>
              <p:nvPr/>
            </p:nvSpPr>
            <p:spPr>
              <a:xfrm>
                <a:off x="3195000" y="5249880"/>
                <a:ext cx="665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lung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4466160" y="5249880"/>
                <a:ext cx="7383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heart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5716440" y="5249880"/>
                <a:ext cx="740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brain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1834560" y="5249880"/>
                <a:ext cx="788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ovary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2" name=""/>
            <p:cNvSpPr/>
            <p:nvPr/>
          </p:nvSpPr>
          <p:spPr>
            <a:xfrm>
              <a:off x="107640" y="4337280"/>
              <a:ext cx="610560" cy="581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200" spc="-1" strike="noStrike">
                  <a:solidFill>
                    <a:srgbClr val="000000"/>
                  </a:solidFill>
                  <a:latin typeface="Arial"/>
                </a:rPr>
                <a:t>B)</a:t>
              </a:r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78920" y="7169400"/>
              <a:ext cx="1374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mean 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± SEM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57480" y="5769000"/>
              <a:ext cx="1183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replicate 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57480" y="6118200"/>
              <a:ext cx="1183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replicate 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57480" y="6469200"/>
              <a:ext cx="1183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replicate 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57480" y="6818400"/>
              <a:ext cx="1183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replicate 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724040" y="5688000"/>
              <a:ext cx="4930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76400" y="7577280"/>
              <a:ext cx="6478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156120" y="7656480"/>
              <a:ext cx="688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0.12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461120" y="7656480"/>
              <a:ext cx="688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0.37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712120" y="7656480"/>
              <a:ext cx="688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0.60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849680" y="7656480"/>
              <a:ext cx="688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0.97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14720" y="7656480"/>
              <a:ext cx="1069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molec/pg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07640" y="289080"/>
              <a:ext cx="610560" cy="581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200" spc="-1" strike="noStrike">
                  <a:solidFill>
                    <a:srgbClr val="000000"/>
                  </a:solidFill>
                  <a:latin typeface="Arial"/>
                </a:rPr>
                <a:t>A)</a:t>
              </a:r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771480" y="2254320"/>
              <a:ext cx="230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075120" y="2260800"/>
              <a:ext cx="0" cy="77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929680" y="2984760"/>
              <a:ext cx="284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 Narrow"/>
                </a:rPr>
                <a:t>x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764640" y="3678480"/>
              <a:ext cx="2741040" cy="2919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300" spc="-1" strike="noStrike">
                  <a:solidFill>
                    <a:srgbClr val="000000"/>
                  </a:solidFill>
                  <a:latin typeface="Arial Narrow"/>
                </a:rPr>
                <a:t>X = 48800 molec/50 ng = 0.976 molec/pg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1-10T11:09:04Z</dcterms:created>
  <dc:creator>CVI 187</dc:creator>
  <dc:description/>
  <dc:language>en-US</dc:language>
  <cp:lastModifiedBy>.</cp:lastModifiedBy>
  <dcterms:modified xsi:type="dcterms:W3CDTF">2007-08-07T08:27:43Z</dcterms:modified>
  <cp:revision>11</cp:revision>
  <dc:subject/>
  <dc:title>Diapositiva 1</dc:title>
</cp:coreProperties>
</file>